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00" autoAdjust="0"/>
    <p:restoredTop sz="94660"/>
  </p:normalViewPr>
  <p:slideViewPr>
    <p:cSldViewPr snapToGrid="0">
      <p:cViewPr varScale="1">
        <p:scale>
          <a:sx n="67" d="100"/>
          <a:sy n="67" d="100"/>
        </p:scale>
        <p:origin x="78" y="7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wmf"/><Relationship Id="rId1" Type="http://schemas.openxmlformats.org/officeDocument/2006/relationships/image" Target="../media/image1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E62FB-0732-4347-B508-5B6D0EB4390B}" type="datetimeFigureOut">
              <a:rPr lang="en-US" smtClean="0"/>
              <a:t>10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D010B4-389D-4D39-AB2E-3104EEA95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6092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E62FB-0732-4347-B508-5B6D0EB4390B}" type="datetimeFigureOut">
              <a:rPr lang="en-US" smtClean="0"/>
              <a:t>10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D010B4-389D-4D39-AB2E-3104EEA95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39083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E62FB-0732-4347-B508-5B6D0EB4390B}" type="datetimeFigureOut">
              <a:rPr lang="en-US" smtClean="0"/>
              <a:t>10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D010B4-389D-4D39-AB2E-3104EEA95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24734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E62FB-0732-4347-B508-5B6D0EB4390B}" type="datetimeFigureOut">
              <a:rPr lang="en-US" smtClean="0"/>
              <a:t>10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D010B4-389D-4D39-AB2E-3104EEA95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30637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E62FB-0732-4347-B508-5B6D0EB4390B}" type="datetimeFigureOut">
              <a:rPr lang="en-US" smtClean="0"/>
              <a:t>10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D010B4-389D-4D39-AB2E-3104EEA95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0994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E62FB-0732-4347-B508-5B6D0EB4390B}" type="datetimeFigureOut">
              <a:rPr lang="en-US" smtClean="0"/>
              <a:t>10/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D010B4-389D-4D39-AB2E-3104EEA95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20326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E62FB-0732-4347-B508-5B6D0EB4390B}" type="datetimeFigureOut">
              <a:rPr lang="en-US" smtClean="0"/>
              <a:t>10/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D010B4-389D-4D39-AB2E-3104EEA95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15506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E62FB-0732-4347-B508-5B6D0EB4390B}" type="datetimeFigureOut">
              <a:rPr lang="en-US" smtClean="0"/>
              <a:t>10/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D010B4-389D-4D39-AB2E-3104EEA95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06853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E62FB-0732-4347-B508-5B6D0EB4390B}" type="datetimeFigureOut">
              <a:rPr lang="en-US" smtClean="0"/>
              <a:t>10/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D010B4-389D-4D39-AB2E-3104EEA95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51330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E62FB-0732-4347-B508-5B6D0EB4390B}" type="datetimeFigureOut">
              <a:rPr lang="en-US" smtClean="0"/>
              <a:t>10/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D010B4-389D-4D39-AB2E-3104EEA95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65414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E62FB-0732-4347-B508-5B6D0EB4390B}" type="datetimeFigureOut">
              <a:rPr lang="en-US" smtClean="0"/>
              <a:t>10/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D010B4-389D-4D39-AB2E-3104EEA95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51985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BE62FB-0732-4347-B508-5B6D0EB4390B}" type="datetimeFigureOut">
              <a:rPr lang="en-US" smtClean="0"/>
              <a:t>10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D010B4-389D-4D39-AB2E-3104EEA95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9108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emf"/><Relationship Id="rId3" Type="http://schemas.openxmlformats.org/officeDocument/2006/relationships/oleObject" Target="../embeddings/oleObject1.bin"/><Relationship Id="rId7" Type="http://schemas.openxmlformats.org/officeDocument/2006/relationships/image" Target="../media/image3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6.emf"/><Relationship Id="rId4" Type="http://schemas.openxmlformats.org/officeDocument/2006/relationships/image" Target="../media/image1.wmf"/><Relationship Id="rId9" Type="http://schemas.openxmlformats.org/officeDocument/2006/relationships/image" Target="../media/image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/>
          </p:nvPr>
        </p:nvGraphicFramePr>
        <p:xfrm>
          <a:off x="2659862" y="3819527"/>
          <a:ext cx="1669396" cy="2442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r:id="rId3" imgW="1414080" imgH="188640" progId="">
                  <p:embed/>
                </p:oleObj>
              </mc:Choice>
              <mc:Fallback>
                <p:oleObj r:id="rId3" imgW="1414080" imgH="188640" progId="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659862" y="3819527"/>
                        <a:ext cx="1669396" cy="244251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/>
          </p:nvPr>
        </p:nvGraphicFramePr>
        <p:xfrm>
          <a:off x="4650234" y="3825598"/>
          <a:ext cx="1669396" cy="2381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r:id="rId5" imgW="1401840" imgH="182520" progId="">
                  <p:embed/>
                </p:oleObj>
              </mc:Choice>
              <mc:Fallback>
                <p:oleObj r:id="rId5" imgW="1401840" imgH="182520" progId="">
                  <p:embed/>
                  <p:pic>
                    <p:nvPicPr>
                      <p:cNvPr id="3" name="Object 2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650234" y="3825598"/>
                        <a:ext cx="1669396" cy="23818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0" name="Picture 9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659862" y="2960474"/>
            <a:ext cx="1669396" cy="29405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650234" y="2960474"/>
            <a:ext cx="1669396" cy="28536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659862" y="3360884"/>
            <a:ext cx="1669396" cy="3249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650234" y="3356108"/>
            <a:ext cx="1669396" cy="32967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5" name="TextBox 14"/>
          <p:cNvSpPr txBox="1"/>
          <p:nvPr/>
        </p:nvSpPr>
        <p:spPr>
          <a:xfrm>
            <a:off x="1584578" y="2901909"/>
            <a:ext cx="1043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-casp3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751291" y="3381508"/>
            <a:ext cx="87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MCL-1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930827" y="3782386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ctin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2571230" y="1765564"/>
            <a:ext cx="1846659" cy="112466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ont</a:t>
            </a:r>
            <a:endParaRPr kumimoji="0" lang="en-US" sz="1800" b="0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HHT+Bort</a:t>
            </a:r>
            <a:endParaRPr kumimoji="0" lang="en-US" sz="1800" b="0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ont</a:t>
            </a:r>
            <a:endParaRPr kumimoji="0" lang="en-US" sz="1800" b="0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HHT+Bort</a:t>
            </a:r>
            <a:endParaRPr kumimoji="0" lang="en-US" sz="1800" b="0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4523905" y="1759493"/>
            <a:ext cx="1846659" cy="112466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ont</a:t>
            </a:r>
            <a:endParaRPr kumimoji="0" lang="en-US" sz="1800" b="0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HHT+Bort</a:t>
            </a:r>
            <a:endParaRPr kumimoji="0" lang="en-US" sz="1800" b="0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ont</a:t>
            </a:r>
            <a:endParaRPr kumimoji="0" lang="en-US" sz="1800" b="0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HHT+Bort</a:t>
            </a:r>
            <a:endParaRPr kumimoji="0" lang="en-US" sz="1800" b="0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402868" y="1218247"/>
            <a:ext cx="11336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OC-</a:t>
            </a:r>
            <a:r>
              <a:rPr kumimoji="0" lang="en-US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mk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5304609" y="1204637"/>
            <a:ext cx="11336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OC-</a:t>
            </a:r>
            <a:r>
              <a:rPr kumimoji="0" lang="en-US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mk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2887094" y="4104012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arnaval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4913598" y="4104012"/>
            <a:ext cx="11934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OCI-LY18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cxnSp>
        <p:nvCxnSpPr>
          <p:cNvPr id="25" name="Straight Connector 24"/>
          <p:cNvCxnSpPr/>
          <p:nvPr/>
        </p:nvCxnSpPr>
        <p:spPr>
          <a:xfrm>
            <a:off x="3510170" y="1587579"/>
            <a:ext cx="81908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>
            <a:off x="5385351" y="1580955"/>
            <a:ext cx="81908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Rectangle 23"/>
          <p:cNvSpPr/>
          <p:nvPr/>
        </p:nvSpPr>
        <p:spPr>
          <a:xfrm>
            <a:off x="1049318" y="213968"/>
            <a:ext cx="123623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igure </a:t>
            </a: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2</a:t>
            </a:r>
            <a:r>
              <a:rPr kumimoji="0" lang="en-US" sz="1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3711791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</Words>
  <Application>Microsoft Office PowerPoint</Application>
  <PresentationFormat>Widescreen</PresentationFormat>
  <Paragraphs>16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ri  Nguyen</dc:creator>
  <cp:lastModifiedBy>Tri  Nguyen</cp:lastModifiedBy>
  <cp:revision>1</cp:revision>
  <dcterms:created xsi:type="dcterms:W3CDTF">2018-10-03T18:46:47Z</dcterms:created>
  <dcterms:modified xsi:type="dcterms:W3CDTF">2018-10-03T18:46:58Z</dcterms:modified>
</cp:coreProperties>
</file>